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5" r:id="rId1"/>
  </p:sldMasterIdLst>
  <p:sldIdLst>
    <p:sldId id="256" r:id="rId2"/>
  </p:sldIdLst>
  <p:sldSz cx="4068763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00" d="100"/>
          <a:sy n="100" d="100"/>
        </p:scale>
        <p:origin x="2539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05157" y="1119505"/>
            <a:ext cx="3458449" cy="2381521"/>
          </a:xfrm>
        </p:spPr>
        <p:txBody>
          <a:bodyPr anchor="b"/>
          <a:lstStyle>
            <a:lvl1pPr algn="ctr">
              <a:defRPr sz="267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508596" y="3592866"/>
            <a:ext cx="3051572" cy="1651546"/>
          </a:xfrm>
        </p:spPr>
        <p:txBody>
          <a:bodyPr/>
          <a:lstStyle>
            <a:lvl1pPr marL="0" indent="0" algn="ctr">
              <a:buNone/>
              <a:defRPr sz="1068"/>
            </a:lvl1pPr>
            <a:lvl2pPr marL="203454" indent="0" algn="ctr">
              <a:buNone/>
              <a:defRPr sz="890"/>
            </a:lvl2pPr>
            <a:lvl3pPr marL="406908" indent="0" algn="ctr">
              <a:buNone/>
              <a:defRPr sz="801"/>
            </a:lvl3pPr>
            <a:lvl4pPr marL="610362" indent="0" algn="ctr">
              <a:buNone/>
              <a:defRPr sz="712"/>
            </a:lvl4pPr>
            <a:lvl5pPr marL="813816" indent="0" algn="ctr">
              <a:buNone/>
              <a:defRPr sz="712"/>
            </a:lvl5pPr>
            <a:lvl6pPr marL="1017270" indent="0" algn="ctr">
              <a:buNone/>
              <a:defRPr sz="712"/>
            </a:lvl6pPr>
            <a:lvl7pPr marL="1220724" indent="0" algn="ctr">
              <a:buNone/>
              <a:defRPr sz="712"/>
            </a:lvl7pPr>
            <a:lvl8pPr marL="1424178" indent="0" algn="ctr">
              <a:buNone/>
              <a:defRPr sz="712"/>
            </a:lvl8pPr>
            <a:lvl9pPr marL="1627632" indent="0" algn="ctr">
              <a:buNone/>
              <a:defRPr sz="712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417102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93639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911709" y="364195"/>
            <a:ext cx="877327" cy="5797040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79727" y="364195"/>
            <a:ext cx="2581122" cy="5797040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71532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709934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775492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77609" y="1705386"/>
            <a:ext cx="3509308" cy="2845473"/>
          </a:xfrm>
        </p:spPr>
        <p:txBody>
          <a:bodyPr anchor="b"/>
          <a:lstStyle>
            <a:lvl1pPr>
              <a:defRPr sz="267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7609" y="4577779"/>
            <a:ext cx="3509308" cy="1496367"/>
          </a:xfrm>
        </p:spPr>
        <p:txBody>
          <a:bodyPr/>
          <a:lstStyle>
            <a:lvl1pPr marL="0" indent="0">
              <a:buNone/>
              <a:defRPr sz="1068">
                <a:solidFill>
                  <a:schemeClr val="tx1"/>
                </a:solidFill>
              </a:defRPr>
            </a:lvl1pPr>
            <a:lvl2pPr marL="203454" indent="0">
              <a:buNone/>
              <a:defRPr sz="890">
                <a:solidFill>
                  <a:schemeClr val="tx1">
                    <a:tint val="75000"/>
                  </a:schemeClr>
                </a:solidFill>
              </a:defRPr>
            </a:lvl2pPr>
            <a:lvl3pPr marL="406908" indent="0">
              <a:buNone/>
              <a:defRPr sz="801">
                <a:solidFill>
                  <a:schemeClr val="tx1">
                    <a:tint val="75000"/>
                  </a:schemeClr>
                </a:solidFill>
              </a:defRPr>
            </a:lvl3pPr>
            <a:lvl4pPr marL="610362" indent="0">
              <a:buNone/>
              <a:defRPr sz="712">
                <a:solidFill>
                  <a:schemeClr val="tx1">
                    <a:tint val="75000"/>
                  </a:schemeClr>
                </a:solidFill>
              </a:defRPr>
            </a:lvl4pPr>
            <a:lvl5pPr marL="813816" indent="0">
              <a:buNone/>
              <a:defRPr sz="712">
                <a:solidFill>
                  <a:schemeClr val="tx1">
                    <a:tint val="75000"/>
                  </a:schemeClr>
                </a:solidFill>
              </a:defRPr>
            </a:lvl5pPr>
            <a:lvl6pPr marL="1017270" indent="0">
              <a:buNone/>
              <a:defRPr sz="712">
                <a:solidFill>
                  <a:schemeClr val="tx1">
                    <a:tint val="75000"/>
                  </a:schemeClr>
                </a:solidFill>
              </a:defRPr>
            </a:lvl6pPr>
            <a:lvl7pPr marL="1220724" indent="0">
              <a:buNone/>
              <a:defRPr sz="712">
                <a:solidFill>
                  <a:schemeClr val="tx1">
                    <a:tint val="75000"/>
                  </a:schemeClr>
                </a:solidFill>
              </a:defRPr>
            </a:lvl7pPr>
            <a:lvl8pPr marL="1424178" indent="0">
              <a:buNone/>
              <a:defRPr sz="712">
                <a:solidFill>
                  <a:schemeClr val="tx1">
                    <a:tint val="75000"/>
                  </a:schemeClr>
                </a:solidFill>
              </a:defRPr>
            </a:lvl8pPr>
            <a:lvl9pPr marL="1627632" indent="0">
              <a:buNone/>
              <a:defRPr sz="71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932601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79728" y="1820976"/>
            <a:ext cx="1729224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59811" y="1820976"/>
            <a:ext cx="1729224" cy="4340259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39506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0257" y="364197"/>
            <a:ext cx="3509308" cy="1322188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80258" y="1676882"/>
            <a:ext cx="1721277" cy="821814"/>
          </a:xfrm>
        </p:spPr>
        <p:txBody>
          <a:bodyPr anchor="b"/>
          <a:lstStyle>
            <a:lvl1pPr marL="0" indent="0">
              <a:buNone/>
              <a:defRPr sz="1068" b="1"/>
            </a:lvl1pPr>
            <a:lvl2pPr marL="203454" indent="0">
              <a:buNone/>
              <a:defRPr sz="890" b="1"/>
            </a:lvl2pPr>
            <a:lvl3pPr marL="406908" indent="0">
              <a:buNone/>
              <a:defRPr sz="801" b="1"/>
            </a:lvl3pPr>
            <a:lvl4pPr marL="610362" indent="0">
              <a:buNone/>
              <a:defRPr sz="712" b="1"/>
            </a:lvl4pPr>
            <a:lvl5pPr marL="813816" indent="0">
              <a:buNone/>
              <a:defRPr sz="712" b="1"/>
            </a:lvl5pPr>
            <a:lvl6pPr marL="1017270" indent="0">
              <a:buNone/>
              <a:defRPr sz="712" b="1"/>
            </a:lvl6pPr>
            <a:lvl7pPr marL="1220724" indent="0">
              <a:buNone/>
              <a:defRPr sz="712" b="1"/>
            </a:lvl7pPr>
            <a:lvl8pPr marL="1424178" indent="0">
              <a:buNone/>
              <a:defRPr sz="712" b="1"/>
            </a:lvl8pPr>
            <a:lvl9pPr marL="1627632" indent="0">
              <a:buNone/>
              <a:defRPr sz="712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80258" y="2498697"/>
            <a:ext cx="1721277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059812" y="1676882"/>
            <a:ext cx="1729754" cy="821814"/>
          </a:xfrm>
        </p:spPr>
        <p:txBody>
          <a:bodyPr anchor="b"/>
          <a:lstStyle>
            <a:lvl1pPr marL="0" indent="0">
              <a:buNone/>
              <a:defRPr sz="1068" b="1"/>
            </a:lvl1pPr>
            <a:lvl2pPr marL="203454" indent="0">
              <a:buNone/>
              <a:defRPr sz="890" b="1"/>
            </a:lvl2pPr>
            <a:lvl3pPr marL="406908" indent="0">
              <a:buNone/>
              <a:defRPr sz="801" b="1"/>
            </a:lvl3pPr>
            <a:lvl4pPr marL="610362" indent="0">
              <a:buNone/>
              <a:defRPr sz="712" b="1"/>
            </a:lvl4pPr>
            <a:lvl5pPr marL="813816" indent="0">
              <a:buNone/>
              <a:defRPr sz="712" b="1"/>
            </a:lvl5pPr>
            <a:lvl6pPr marL="1017270" indent="0">
              <a:buNone/>
              <a:defRPr sz="712" b="1"/>
            </a:lvl6pPr>
            <a:lvl7pPr marL="1220724" indent="0">
              <a:buNone/>
              <a:defRPr sz="712" b="1"/>
            </a:lvl7pPr>
            <a:lvl8pPr marL="1424178" indent="0">
              <a:buNone/>
              <a:defRPr sz="712" b="1"/>
            </a:lvl8pPr>
            <a:lvl9pPr marL="1627632" indent="0">
              <a:buNone/>
              <a:defRPr sz="712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059812" y="2498697"/>
            <a:ext cx="1729754" cy="367520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4067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89676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2939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0257" y="456036"/>
            <a:ext cx="1312282" cy="1596126"/>
          </a:xfrm>
        </p:spPr>
        <p:txBody>
          <a:bodyPr anchor="b"/>
          <a:lstStyle>
            <a:lvl1pPr>
              <a:defRPr sz="14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729754" y="984912"/>
            <a:ext cx="2059811" cy="4861216"/>
          </a:xfrm>
        </p:spPr>
        <p:txBody>
          <a:bodyPr/>
          <a:lstStyle>
            <a:lvl1pPr>
              <a:defRPr sz="1424"/>
            </a:lvl1pPr>
            <a:lvl2pPr>
              <a:defRPr sz="1246"/>
            </a:lvl2pPr>
            <a:lvl3pPr>
              <a:defRPr sz="1068"/>
            </a:lvl3pPr>
            <a:lvl4pPr>
              <a:defRPr sz="890"/>
            </a:lvl4pPr>
            <a:lvl5pPr>
              <a:defRPr sz="890"/>
            </a:lvl5pPr>
            <a:lvl6pPr>
              <a:defRPr sz="890"/>
            </a:lvl6pPr>
            <a:lvl7pPr>
              <a:defRPr sz="890"/>
            </a:lvl7pPr>
            <a:lvl8pPr>
              <a:defRPr sz="890"/>
            </a:lvl8pPr>
            <a:lvl9pPr>
              <a:defRPr sz="89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0257" y="2052161"/>
            <a:ext cx="1312282" cy="3801883"/>
          </a:xfrm>
        </p:spPr>
        <p:txBody>
          <a:bodyPr/>
          <a:lstStyle>
            <a:lvl1pPr marL="0" indent="0">
              <a:buNone/>
              <a:defRPr sz="712"/>
            </a:lvl1pPr>
            <a:lvl2pPr marL="203454" indent="0">
              <a:buNone/>
              <a:defRPr sz="623"/>
            </a:lvl2pPr>
            <a:lvl3pPr marL="406908" indent="0">
              <a:buNone/>
              <a:defRPr sz="534"/>
            </a:lvl3pPr>
            <a:lvl4pPr marL="610362" indent="0">
              <a:buNone/>
              <a:defRPr sz="445"/>
            </a:lvl4pPr>
            <a:lvl5pPr marL="813816" indent="0">
              <a:buNone/>
              <a:defRPr sz="445"/>
            </a:lvl5pPr>
            <a:lvl6pPr marL="1017270" indent="0">
              <a:buNone/>
              <a:defRPr sz="445"/>
            </a:lvl6pPr>
            <a:lvl7pPr marL="1220724" indent="0">
              <a:buNone/>
              <a:defRPr sz="445"/>
            </a:lvl7pPr>
            <a:lvl8pPr marL="1424178" indent="0">
              <a:buNone/>
              <a:defRPr sz="445"/>
            </a:lvl8pPr>
            <a:lvl9pPr marL="1627632" indent="0">
              <a:buNone/>
              <a:defRPr sz="445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17106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80257" y="456036"/>
            <a:ext cx="1312282" cy="1596126"/>
          </a:xfrm>
        </p:spPr>
        <p:txBody>
          <a:bodyPr anchor="b"/>
          <a:lstStyle>
            <a:lvl1pPr>
              <a:defRPr sz="1424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729754" y="984912"/>
            <a:ext cx="2059811" cy="4861216"/>
          </a:xfrm>
        </p:spPr>
        <p:txBody>
          <a:bodyPr anchor="t"/>
          <a:lstStyle>
            <a:lvl1pPr marL="0" indent="0">
              <a:buNone/>
              <a:defRPr sz="1424"/>
            </a:lvl1pPr>
            <a:lvl2pPr marL="203454" indent="0">
              <a:buNone/>
              <a:defRPr sz="1246"/>
            </a:lvl2pPr>
            <a:lvl3pPr marL="406908" indent="0">
              <a:buNone/>
              <a:defRPr sz="1068"/>
            </a:lvl3pPr>
            <a:lvl4pPr marL="610362" indent="0">
              <a:buNone/>
              <a:defRPr sz="890"/>
            </a:lvl4pPr>
            <a:lvl5pPr marL="813816" indent="0">
              <a:buNone/>
              <a:defRPr sz="890"/>
            </a:lvl5pPr>
            <a:lvl6pPr marL="1017270" indent="0">
              <a:buNone/>
              <a:defRPr sz="890"/>
            </a:lvl6pPr>
            <a:lvl7pPr marL="1220724" indent="0">
              <a:buNone/>
              <a:defRPr sz="890"/>
            </a:lvl7pPr>
            <a:lvl8pPr marL="1424178" indent="0">
              <a:buNone/>
              <a:defRPr sz="890"/>
            </a:lvl8pPr>
            <a:lvl9pPr marL="1627632" indent="0">
              <a:buNone/>
              <a:defRPr sz="89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80257" y="2052161"/>
            <a:ext cx="1312282" cy="3801883"/>
          </a:xfrm>
        </p:spPr>
        <p:txBody>
          <a:bodyPr/>
          <a:lstStyle>
            <a:lvl1pPr marL="0" indent="0">
              <a:buNone/>
              <a:defRPr sz="712"/>
            </a:lvl1pPr>
            <a:lvl2pPr marL="203454" indent="0">
              <a:buNone/>
              <a:defRPr sz="623"/>
            </a:lvl2pPr>
            <a:lvl3pPr marL="406908" indent="0">
              <a:buNone/>
              <a:defRPr sz="534"/>
            </a:lvl3pPr>
            <a:lvl4pPr marL="610362" indent="0">
              <a:buNone/>
              <a:defRPr sz="445"/>
            </a:lvl4pPr>
            <a:lvl5pPr marL="813816" indent="0">
              <a:buNone/>
              <a:defRPr sz="445"/>
            </a:lvl5pPr>
            <a:lvl6pPr marL="1017270" indent="0">
              <a:buNone/>
              <a:defRPr sz="445"/>
            </a:lvl6pPr>
            <a:lvl7pPr marL="1220724" indent="0">
              <a:buNone/>
              <a:defRPr sz="445"/>
            </a:lvl7pPr>
            <a:lvl8pPr marL="1424178" indent="0">
              <a:buNone/>
              <a:defRPr sz="445"/>
            </a:lvl8pPr>
            <a:lvl9pPr marL="1627632" indent="0">
              <a:buNone/>
              <a:defRPr sz="445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96495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79728" y="364197"/>
            <a:ext cx="3509308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79728" y="1820976"/>
            <a:ext cx="3509308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79727" y="6340167"/>
            <a:ext cx="915472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5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D7AC53-DAEB-4CAA-B161-37E9F173E032}" type="datetimeFigureOut">
              <a:rPr lang="de-DE" smtClean="0"/>
              <a:t>22.10.2018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347778" y="6340167"/>
            <a:ext cx="137320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5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873564" y="6340167"/>
            <a:ext cx="915472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53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53920F-5F94-4CDB-909A-63E6042848D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225606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6" r:id="rId1"/>
    <p:sldLayoutId id="2147483687" r:id="rId2"/>
    <p:sldLayoutId id="2147483688" r:id="rId3"/>
    <p:sldLayoutId id="2147483689" r:id="rId4"/>
    <p:sldLayoutId id="2147483690" r:id="rId5"/>
    <p:sldLayoutId id="2147483691" r:id="rId6"/>
    <p:sldLayoutId id="2147483692" r:id="rId7"/>
    <p:sldLayoutId id="2147483693" r:id="rId8"/>
    <p:sldLayoutId id="2147483694" r:id="rId9"/>
    <p:sldLayoutId id="2147483695" r:id="rId10"/>
    <p:sldLayoutId id="2147483696" r:id="rId11"/>
    <p:sldLayoutId id="2147483697" r:id="rId12"/>
  </p:sldLayoutIdLst>
  <p:txStyles>
    <p:titleStyle>
      <a:lvl1pPr algn="l" defTabSz="406908" rtl="0" eaLnBrk="1" latinLnBrk="0" hangingPunct="1">
        <a:lnSpc>
          <a:spcPct val="90000"/>
        </a:lnSpc>
        <a:spcBef>
          <a:spcPct val="0"/>
        </a:spcBef>
        <a:buNone/>
        <a:defRPr sz="1958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01727" indent="-101727" algn="l" defTabSz="406908" rtl="0" eaLnBrk="1" latinLnBrk="0" hangingPunct="1">
        <a:lnSpc>
          <a:spcPct val="90000"/>
        </a:lnSpc>
        <a:spcBef>
          <a:spcPts val="445"/>
        </a:spcBef>
        <a:buFont typeface="Arial" panose="020B0604020202020204" pitchFamily="34" charset="0"/>
        <a:buChar char="•"/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05181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1068" kern="1200">
          <a:solidFill>
            <a:schemeClr val="tx1"/>
          </a:solidFill>
          <a:latin typeface="+mn-lt"/>
          <a:ea typeface="+mn-ea"/>
          <a:cs typeface="+mn-cs"/>
        </a:defRPr>
      </a:lvl2pPr>
      <a:lvl3pPr marL="508635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90" kern="1200">
          <a:solidFill>
            <a:schemeClr val="tx1"/>
          </a:solidFill>
          <a:latin typeface="+mn-lt"/>
          <a:ea typeface="+mn-ea"/>
          <a:cs typeface="+mn-cs"/>
        </a:defRPr>
      </a:lvl3pPr>
      <a:lvl4pPr marL="712089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1" kern="1200">
          <a:solidFill>
            <a:schemeClr val="tx1"/>
          </a:solidFill>
          <a:latin typeface="+mn-lt"/>
          <a:ea typeface="+mn-ea"/>
          <a:cs typeface="+mn-cs"/>
        </a:defRPr>
      </a:lvl4pPr>
      <a:lvl5pPr marL="915543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1" kern="1200">
          <a:solidFill>
            <a:schemeClr val="tx1"/>
          </a:solidFill>
          <a:latin typeface="+mn-lt"/>
          <a:ea typeface="+mn-ea"/>
          <a:cs typeface="+mn-cs"/>
        </a:defRPr>
      </a:lvl5pPr>
      <a:lvl6pPr marL="1118997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1" kern="1200">
          <a:solidFill>
            <a:schemeClr val="tx1"/>
          </a:solidFill>
          <a:latin typeface="+mn-lt"/>
          <a:ea typeface="+mn-ea"/>
          <a:cs typeface="+mn-cs"/>
        </a:defRPr>
      </a:lvl6pPr>
      <a:lvl7pPr marL="1322451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1" kern="1200">
          <a:solidFill>
            <a:schemeClr val="tx1"/>
          </a:solidFill>
          <a:latin typeface="+mn-lt"/>
          <a:ea typeface="+mn-ea"/>
          <a:cs typeface="+mn-cs"/>
        </a:defRPr>
      </a:lvl7pPr>
      <a:lvl8pPr marL="1525905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1" kern="1200">
          <a:solidFill>
            <a:schemeClr val="tx1"/>
          </a:solidFill>
          <a:latin typeface="+mn-lt"/>
          <a:ea typeface="+mn-ea"/>
          <a:cs typeface="+mn-cs"/>
        </a:defRPr>
      </a:lvl8pPr>
      <a:lvl9pPr marL="1729359" indent="-101727" algn="l" defTabSz="406908" rtl="0" eaLnBrk="1" latinLnBrk="0" hangingPunct="1">
        <a:lnSpc>
          <a:spcPct val="90000"/>
        </a:lnSpc>
        <a:spcBef>
          <a:spcPts val="223"/>
        </a:spcBef>
        <a:buFont typeface="Arial" panose="020B0604020202020204" pitchFamily="34" charset="0"/>
        <a:buChar char="•"/>
        <a:defRPr sz="80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1pPr>
      <a:lvl2pPr marL="203454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2pPr>
      <a:lvl3pPr marL="406908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3pPr>
      <a:lvl4pPr marL="610362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4pPr>
      <a:lvl5pPr marL="813816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5pPr>
      <a:lvl6pPr marL="1017270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6pPr>
      <a:lvl7pPr marL="1220724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7pPr>
      <a:lvl8pPr marL="1424178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8pPr>
      <a:lvl9pPr marL="1627632" algn="l" defTabSz="406908" rtl="0" eaLnBrk="1" latinLnBrk="0" hangingPunct="1">
        <a:defRPr sz="80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uppieren 27">
            <a:extLst>
              <a:ext uri="{FF2B5EF4-FFF2-40B4-BE49-F238E27FC236}">
                <a16:creationId xmlns:a16="http://schemas.microsoft.com/office/drawing/2014/main" id="{EE01E0AA-3CF4-4EFE-A996-8CB2DBE6B14B}"/>
              </a:ext>
            </a:extLst>
          </p:cNvPr>
          <p:cNvGrpSpPr/>
          <p:nvPr/>
        </p:nvGrpSpPr>
        <p:grpSpPr>
          <a:xfrm>
            <a:off x="26510" y="0"/>
            <a:ext cx="4015742" cy="5240270"/>
            <a:chOff x="26512" y="49599"/>
            <a:chExt cx="4015742" cy="5240271"/>
          </a:xfrm>
        </p:grpSpPr>
        <p:sp>
          <p:nvSpPr>
            <p:cNvPr id="5" name="Rechteck 4">
              <a:extLst>
                <a:ext uri="{FF2B5EF4-FFF2-40B4-BE49-F238E27FC236}">
                  <a16:creationId xmlns:a16="http://schemas.microsoft.com/office/drawing/2014/main" id="{040189A1-47DE-41B2-A298-48AB839AC2C5}"/>
                </a:ext>
              </a:extLst>
            </p:cNvPr>
            <p:cNvSpPr/>
            <p:nvPr/>
          </p:nvSpPr>
          <p:spPr>
            <a:xfrm>
              <a:off x="711302" y="4475050"/>
              <a:ext cx="2646158" cy="81482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wrap="square" lIns="72000" tIns="72000" rIns="72000" bIns="72000" rtlCol="0" anchor="ctr">
              <a:spAutoFit/>
            </a:bodyPr>
            <a:lstStyle/>
            <a:p>
              <a:pPr algn="ctr"/>
              <a:r>
                <a:rPr lang="en-US" sz="1100" b="1" dirty="0">
                  <a:solidFill>
                    <a:schemeClr val="tx1"/>
                  </a:solidFill>
                </a:rPr>
                <a:t>Data analysis</a:t>
              </a:r>
            </a:p>
            <a:p>
              <a:pPr marL="171478" indent="-171478">
                <a:spcBef>
                  <a:spcPts val="300"/>
                </a:spcBef>
                <a:buFont typeface="Arial" panose="020B0604020202020204" pitchFamily="34" charset="0"/>
                <a:buChar char="•"/>
              </a:pPr>
              <a:r>
                <a:rPr lang="en-US" sz="1000" dirty="0">
                  <a:solidFill>
                    <a:schemeClr val="tx1"/>
                  </a:solidFill>
                </a:rPr>
                <a:t>Identification &amp; Quantification of Proteins</a:t>
              </a:r>
            </a:p>
            <a:p>
              <a:pPr marL="171478" indent="-171478">
                <a:buFont typeface="Arial" panose="020B0604020202020204" pitchFamily="34" charset="0"/>
                <a:buChar char="•"/>
              </a:pPr>
              <a:r>
                <a:rPr lang="en-US" sz="1000" dirty="0">
                  <a:solidFill>
                    <a:schemeClr val="tx1"/>
                  </a:solidFill>
                </a:rPr>
                <a:t>Data filtering (quality criteria)</a:t>
              </a:r>
            </a:p>
            <a:p>
              <a:pPr marL="171478" indent="-171478">
                <a:buFont typeface="Arial" panose="020B0604020202020204" pitchFamily="34" charset="0"/>
                <a:buChar char="•"/>
              </a:pPr>
              <a:r>
                <a:rPr lang="en-US" sz="1000" dirty="0">
                  <a:solidFill>
                    <a:schemeClr val="tx1"/>
                  </a:solidFill>
                </a:rPr>
                <a:t>Statistical analyses</a:t>
              </a:r>
            </a:p>
          </p:txBody>
        </p:sp>
        <p:grpSp>
          <p:nvGrpSpPr>
            <p:cNvPr id="6" name="Gruppieren 5">
              <a:extLst>
                <a:ext uri="{FF2B5EF4-FFF2-40B4-BE49-F238E27FC236}">
                  <a16:creationId xmlns:a16="http://schemas.microsoft.com/office/drawing/2014/main" id="{4A4EBE29-42CA-41B9-8EDD-999B1CE96989}"/>
                </a:ext>
              </a:extLst>
            </p:cNvPr>
            <p:cNvGrpSpPr/>
            <p:nvPr/>
          </p:nvGrpSpPr>
          <p:grpSpPr>
            <a:xfrm>
              <a:off x="26512" y="389851"/>
              <a:ext cx="4015742" cy="3968106"/>
              <a:chOff x="2897505" y="1066393"/>
              <a:chExt cx="4015742" cy="3961244"/>
            </a:xfrm>
          </p:grpSpPr>
          <p:grpSp>
            <p:nvGrpSpPr>
              <p:cNvPr id="9" name="Gruppieren 8">
                <a:extLst>
                  <a:ext uri="{FF2B5EF4-FFF2-40B4-BE49-F238E27FC236}">
                    <a16:creationId xmlns:a16="http://schemas.microsoft.com/office/drawing/2014/main" id="{6A18B891-2C4A-4DBD-A3EC-0EB11D5BE53D}"/>
                  </a:ext>
                </a:extLst>
              </p:cNvPr>
              <p:cNvGrpSpPr/>
              <p:nvPr/>
            </p:nvGrpSpPr>
            <p:grpSpPr>
              <a:xfrm>
                <a:off x="2897505" y="1066393"/>
                <a:ext cx="4015742" cy="3616725"/>
                <a:chOff x="2897505" y="1066393"/>
                <a:chExt cx="4015742" cy="3616725"/>
              </a:xfrm>
            </p:grpSpPr>
            <p:grpSp>
              <p:nvGrpSpPr>
                <p:cNvPr id="11" name="Gruppieren 10">
                  <a:extLst>
                    <a:ext uri="{FF2B5EF4-FFF2-40B4-BE49-F238E27FC236}">
                      <a16:creationId xmlns:a16="http://schemas.microsoft.com/office/drawing/2014/main" id="{415A091F-55EA-4C9E-8A56-BD656811DDBB}"/>
                    </a:ext>
                  </a:extLst>
                </p:cNvPr>
                <p:cNvGrpSpPr/>
                <p:nvPr/>
              </p:nvGrpSpPr>
              <p:grpSpPr>
                <a:xfrm>
                  <a:off x="2897505" y="1066393"/>
                  <a:ext cx="1920240" cy="3616725"/>
                  <a:chOff x="4450080" y="132943"/>
                  <a:chExt cx="1920240" cy="3616725"/>
                </a:xfrm>
              </p:grpSpPr>
              <p:sp>
                <p:nvSpPr>
                  <p:cNvPr id="18" name="Rechteck 17">
                    <a:extLst>
                      <a:ext uri="{FF2B5EF4-FFF2-40B4-BE49-F238E27FC236}">
                        <a16:creationId xmlns:a16="http://schemas.microsoft.com/office/drawing/2014/main" id="{51D5AA6A-F9B6-48AA-B300-EDAAB942B2DE}"/>
                      </a:ext>
                    </a:extLst>
                  </p:cNvPr>
                  <p:cNvSpPr/>
                  <p:nvPr/>
                </p:nvSpPr>
                <p:spPr>
                  <a:xfrm>
                    <a:off x="4450080" y="132943"/>
                    <a:ext cx="1920240" cy="659789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ctr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Treatment of cells</a:t>
                    </a:r>
                  </a:p>
                  <a:p>
                    <a:pPr marL="171478" indent="-171478">
                      <a:spcBef>
                        <a:spcPts val="300"/>
                      </a:spcBef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Incubation in medium with glucose/sucrose (2 groups)</a:t>
                    </a:r>
                    <a:endParaRPr lang="en-US" sz="1000" b="1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19" name="Pfeil: nach unten 18">
                    <a:extLst>
                      <a:ext uri="{FF2B5EF4-FFF2-40B4-BE49-F238E27FC236}">
                        <a16:creationId xmlns:a16="http://schemas.microsoft.com/office/drawing/2014/main" id="{02F84950-4A46-4BBA-B860-7DBCFBF8053D}"/>
                      </a:ext>
                    </a:extLst>
                  </p:cNvPr>
                  <p:cNvSpPr/>
                  <p:nvPr/>
                </p:nvSpPr>
                <p:spPr>
                  <a:xfrm>
                    <a:off x="5326380" y="843078"/>
                    <a:ext cx="167640" cy="175260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/>
                  </a:p>
                </p:txBody>
              </p:sp>
              <p:sp>
                <p:nvSpPr>
                  <p:cNvPr id="20" name="Rechteck 19">
                    <a:extLst>
                      <a:ext uri="{FF2B5EF4-FFF2-40B4-BE49-F238E27FC236}">
                        <a16:creationId xmlns:a16="http://schemas.microsoft.com/office/drawing/2014/main" id="{736510BF-D463-43C6-B0DC-CD070CE76165}"/>
                      </a:ext>
                    </a:extLst>
                  </p:cNvPr>
                  <p:cNvSpPr/>
                  <p:nvPr/>
                </p:nvSpPr>
                <p:spPr>
                  <a:xfrm>
                    <a:off x="4450080" y="1069524"/>
                    <a:ext cx="1920240" cy="828774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ctr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Protein extraction &amp; </a:t>
                    </a:r>
                    <a:br>
                      <a:rPr lang="en-US" sz="1100" b="1" dirty="0">
                        <a:solidFill>
                          <a:schemeClr val="tx1"/>
                        </a:solidFill>
                      </a:rPr>
                    </a:br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peptide generation</a:t>
                    </a:r>
                  </a:p>
                  <a:p>
                    <a:pPr marL="171478" indent="-171478">
                      <a:spcBef>
                        <a:spcPts val="300"/>
                      </a:spcBef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Reduction, alkylation and tryptic digest</a:t>
                    </a:r>
                    <a:endParaRPr lang="en-US" sz="1000" b="1" dirty="0">
                      <a:solidFill>
                        <a:schemeClr val="tx1"/>
                      </a:solidFill>
                    </a:endParaRPr>
                  </a:p>
                </p:txBody>
              </p:sp>
              <p:sp>
                <p:nvSpPr>
                  <p:cNvPr id="21" name="Rechteck 20">
                    <a:extLst>
                      <a:ext uri="{FF2B5EF4-FFF2-40B4-BE49-F238E27FC236}">
                        <a16:creationId xmlns:a16="http://schemas.microsoft.com/office/drawing/2014/main" id="{3F74BA50-8362-4DFC-8998-E8106F3D22A1}"/>
                      </a:ext>
                    </a:extLst>
                  </p:cNvPr>
                  <p:cNvSpPr/>
                  <p:nvPr/>
                </p:nvSpPr>
                <p:spPr>
                  <a:xfrm>
                    <a:off x="4450080" y="2175085"/>
                    <a:ext cx="1920240" cy="659789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ctr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Peptide separation</a:t>
                    </a:r>
                  </a:p>
                  <a:p>
                    <a:pPr marL="171478" indent="-171478">
                      <a:spcBef>
                        <a:spcPts val="300"/>
                      </a:spcBef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Trap column</a:t>
                    </a:r>
                  </a:p>
                  <a:p>
                    <a:pPr marL="171478" indent="-171478">
                      <a:buFont typeface="Arial" panose="020B0604020202020204" pitchFamily="34" charset="0"/>
                      <a:buChar char="•"/>
                    </a:pPr>
                    <a:r>
                      <a:rPr lang="en-US" sz="1000">
                        <a:solidFill>
                          <a:schemeClr val="tx1"/>
                        </a:solidFill>
                      </a:rPr>
                      <a:t>Analytical </a:t>
                    </a:r>
                    <a:r>
                      <a:rPr lang="en-US" sz="1000" dirty="0">
                        <a:solidFill>
                          <a:schemeClr val="tx1"/>
                        </a:solidFill>
                      </a:rPr>
                      <a:t>column</a:t>
                    </a:r>
                  </a:p>
                </p:txBody>
              </p:sp>
              <p:sp>
                <p:nvSpPr>
                  <p:cNvPr id="22" name="Pfeil: nach unten 21">
                    <a:extLst>
                      <a:ext uri="{FF2B5EF4-FFF2-40B4-BE49-F238E27FC236}">
                        <a16:creationId xmlns:a16="http://schemas.microsoft.com/office/drawing/2014/main" id="{624548AF-B17D-4E20-A3B6-9D3A9A18084A}"/>
                      </a:ext>
                    </a:extLst>
                  </p:cNvPr>
                  <p:cNvSpPr/>
                  <p:nvPr/>
                </p:nvSpPr>
                <p:spPr>
                  <a:xfrm>
                    <a:off x="5326380" y="1949481"/>
                    <a:ext cx="167640" cy="175260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/>
                  </a:p>
                </p:txBody>
              </p:sp>
              <p:sp>
                <p:nvSpPr>
                  <p:cNvPr id="23" name="Rechteck 22">
                    <a:extLst>
                      <a:ext uri="{FF2B5EF4-FFF2-40B4-BE49-F238E27FC236}">
                        <a16:creationId xmlns:a16="http://schemas.microsoft.com/office/drawing/2014/main" id="{E59E63EE-DE18-4DDD-A66F-6EDC879C445F}"/>
                      </a:ext>
                    </a:extLst>
                  </p:cNvPr>
                  <p:cNvSpPr/>
                  <p:nvPr/>
                </p:nvSpPr>
                <p:spPr>
                  <a:xfrm>
                    <a:off x="4450080" y="3089879"/>
                    <a:ext cx="1920240" cy="659789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ctr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Tandem mass spectrometry</a:t>
                    </a:r>
                  </a:p>
                  <a:p>
                    <a:pPr marL="171478" indent="-171478">
                      <a:spcBef>
                        <a:spcPts val="300"/>
                      </a:spcBef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Quadrupole (MS1)</a:t>
                    </a:r>
                  </a:p>
                  <a:p>
                    <a:pPr marL="171478" indent="-171478"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Orbitrap (MS2)</a:t>
                    </a:r>
                  </a:p>
                </p:txBody>
              </p:sp>
              <p:sp>
                <p:nvSpPr>
                  <p:cNvPr id="24" name="Pfeil: nach unten 23">
                    <a:extLst>
                      <a:ext uri="{FF2B5EF4-FFF2-40B4-BE49-F238E27FC236}">
                        <a16:creationId xmlns:a16="http://schemas.microsoft.com/office/drawing/2014/main" id="{48DD6789-2803-479D-ADA9-1C1B74A76C36}"/>
                      </a:ext>
                    </a:extLst>
                  </p:cNvPr>
                  <p:cNvSpPr/>
                  <p:nvPr/>
                </p:nvSpPr>
                <p:spPr>
                  <a:xfrm>
                    <a:off x="5326380" y="2894837"/>
                    <a:ext cx="167640" cy="175260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/>
                  </a:p>
                </p:txBody>
              </p:sp>
            </p:grpSp>
            <p:grpSp>
              <p:nvGrpSpPr>
                <p:cNvPr id="12" name="Gruppieren 11">
                  <a:extLst>
                    <a:ext uri="{FF2B5EF4-FFF2-40B4-BE49-F238E27FC236}">
                      <a16:creationId xmlns:a16="http://schemas.microsoft.com/office/drawing/2014/main" id="{56604073-EB9C-4578-A00E-E2F5CDE6E837}"/>
                    </a:ext>
                  </a:extLst>
                </p:cNvPr>
                <p:cNvGrpSpPr/>
                <p:nvPr/>
              </p:nvGrpSpPr>
              <p:grpSpPr>
                <a:xfrm>
                  <a:off x="4993007" y="1072726"/>
                  <a:ext cx="1920240" cy="2855735"/>
                  <a:chOff x="6720842" y="1043705"/>
                  <a:chExt cx="1920240" cy="2855735"/>
                </a:xfrm>
              </p:grpSpPr>
              <p:sp>
                <p:nvSpPr>
                  <p:cNvPr id="13" name="Rechteck 12">
                    <a:extLst>
                      <a:ext uri="{FF2B5EF4-FFF2-40B4-BE49-F238E27FC236}">
                        <a16:creationId xmlns:a16="http://schemas.microsoft.com/office/drawing/2014/main" id="{A188FDC1-7A4C-4F28-88FF-348F7687590C}"/>
                      </a:ext>
                    </a:extLst>
                  </p:cNvPr>
                  <p:cNvSpPr/>
                  <p:nvPr/>
                </p:nvSpPr>
                <p:spPr>
                  <a:xfrm>
                    <a:off x="6720842" y="1043705"/>
                    <a:ext cx="1920240" cy="659789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ctr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DNA Isolation</a:t>
                    </a:r>
                  </a:p>
                  <a:p>
                    <a:pPr marL="171478" indent="-171478">
                      <a:spcBef>
                        <a:spcPts val="300"/>
                      </a:spcBef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High molecular weight DNA from exp. cultures</a:t>
                    </a:r>
                  </a:p>
                </p:txBody>
              </p:sp>
              <p:sp>
                <p:nvSpPr>
                  <p:cNvPr id="14" name="Pfeil: nach unten 13">
                    <a:extLst>
                      <a:ext uri="{FF2B5EF4-FFF2-40B4-BE49-F238E27FC236}">
                        <a16:creationId xmlns:a16="http://schemas.microsoft.com/office/drawing/2014/main" id="{1FC5897B-501E-41FC-A157-16A887A61723}"/>
                      </a:ext>
                    </a:extLst>
                  </p:cNvPr>
                  <p:cNvSpPr/>
                  <p:nvPr/>
                </p:nvSpPr>
                <p:spPr>
                  <a:xfrm>
                    <a:off x="7597142" y="1752860"/>
                    <a:ext cx="167640" cy="175260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/>
                  </a:p>
                </p:txBody>
              </p:sp>
              <p:sp>
                <p:nvSpPr>
                  <p:cNvPr id="15" name="Rechteck 14">
                    <a:extLst>
                      <a:ext uri="{FF2B5EF4-FFF2-40B4-BE49-F238E27FC236}">
                        <a16:creationId xmlns:a16="http://schemas.microsoft.com/office/drawing/2014/main" id="{E380FED9-9CEE-4F30-86C6-429F4455DF79}"/>
                      </a:ext>
                    </a:extLst>
                  </p:cNvPr>
                  <p:cNvSpPr/>
                  <p:nvPr/>
                </p:nvSpPr>
                <p:spPr>
                  <a:xfrm>
                    <a:off x="6720842" y="1978977"/>
                    <a:ext cx="1920240" cy="828774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ctr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Genome sequencing &amp; assembly</a:t>
                    </a:r>
                  </a:p>
                  <a:p>
                    <a:pPr marL="171478" indent="-171478">
                      <a:spcBef>
                        <a:spcPts val="300"/>
                      </a:spcBef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Illumina MiSeq® Technology</a:t>
                    </a:r>
                  </a:p>
                  <a:p>
                    <a:pPr marL="171478" indent="-171478"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SPAdes 3.9 assembly algorithm</a:t>
                    </a:r>
                  </a:p>
                </p:txBody>
              </p:sp>
              <p:sp>
                <p:nvSpPr>
                  <p:cNvPr id="16" name="Rechteck 15">
                    <a:extLst>
                      <a:ext uri="{FF2B5EF4-FFF2-40B4-BE49-F238E27FC236}">
                        <a16:creationId xmlns:a16="http://schemas.microsoft.com/office/drawing/2014/main" id="{58E8A1D8-3A0D-4497-8845-D3BC43C2F65A}"/>
                      </a:ext>
                    </a:extLst>
                  </p:cNvPr>
                  <p:cNvSpPr/>
                  <p:nvPr/>
                </p:nvSpPr>
                <p:spPr>
                  <a:xfrm>
                    <a:off x="6720842" y="3086029"/>
                    <a:ext cx="1920240" cy="813411"/>
                  </a:xfrm>
                  <a:prstGeom prst="rect">
                    <a:avLst/>
                  </a:prstGeom>
                  <a:noFill/>
                  <a:ln w="635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lIns="72000" tIns="72000" rIns="72000" bIns="72000" rtlCol="0" anchor="ctr">
                    <a:spAutoFit/>
                  </a:bodyPr>
                  <a:lstStyle/>
                  <a:p>
                    <a:pPr algn="ctr"/>
                    <a:r>
                      <a:rPr lang="en-US" sz="1100" b="1" dirty="0">
                        <a:solidFill>
                          <a:schemeClr val="tx1"/>
                        </a:solidFill>
                      </a:rPr>
                      <a:t>Genome annotation</a:t>
                    </a:r>
                  </a:p>
                  <a:p>
                    <a:pPr marL="171478" indent="-171478">
                      <a:spcBef>
                        <a:spcPts val="300"/>
                      </a:spcBef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RAST annotation / SEED subsystem analysis</a:t>
                    </a:r>
                  </a:p>
                  <a:p>
                    <a:pPr marL="171478" indent="-171478">
                      <a:buFont typeface="Arial" panose="020B0604020202020204" pitchFamily="34" charset="0"/>
                      <a:buChar char="•"/>
                    </a:pPr>
                    <a:r>
                      <a:rPr lang="en-US" sz="1000" dirty="0">
                        <a:solidFill>
                          <a:schemeClr val="tx1"/>
                        </a:solidFill>
                      </a:rPr>
                      <a:t>PGAP annotation (NCBI)</a:t>
                    </a:r>
                  </a:p>
                </p:txBody>
              </p:sp>
              <p:sp>
                <p:nvSpPr>
                  <p:cNvPr id="17" name="Pfeil: nach unten 16">
                    <a:extLst>
                      <a:ext uri="{FF2B5EF4-FFF2-40B4-BE49-F238E27FC236}">
                        <a16:creationId xmlns:a16="http://schemas.microsoft.com/office/drawing/2014/main" id="{ACE04030-2807-487B-8C60-429BEDFB12FA}"/>
                      </a:ext>
                    </a:extLst>
                  </p:cNvPr>
                  <p:cNvSpPr/>
                  <p:nvPr/>
                </p:nvSpPr>
                <p:spPr>
                  <a:xfrm>
                    <a:off x="7597142" y="2859261"/>
                    <a:ext cx="167640" cy="175260"/>
                  </a:xfrm>
                  <a:prstGeom prst="downArrow">
                    <a:avLst/>
                  </a:prstGeom>
                  <a:solidFill>
                    <a:schemeClr val="tx1"/>
                  </a:solidFill>
                  <a:ln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de-DE"/>
                  </a:p>
                </p:txBody>
              </p:sp>
            </p:grpSp>
          </p:grpSp>
          <p:sp>
            <p:nvSpPr>
              <p:cNvPr id="10" name="Geschweifte Klammer links 9">
                <a:extLst>
                  <a:ext uri="{FF2B5EF4-FFF2-40B4-BE49-F238E27FC236}">
                    <a16:creationId xmlns:a16="http://schemas.microsoft.com/office/drawing/2014/main" id="{AB6F232F-19AE-485B-B865-DAEDDC91D691}"/>
                  </a:ext>
                </a:extLst>
              </p:cNvPr>
              <p:cNvSpPr/>
              <p:nvPr/>
            </p:nvSpPr>
            <p:spPr>
              <a:xfrm rot="16200000">
                <a:off x="4817745" y="2932138"/>
                <a:ext cx="175260" cy="4015738"/>
              </a:xfrm>
              <a:prstGeom prst="leftBrace">
                <a:avLst/>
              </a:prstGeom>
              <a:ln w="6350" cap="sq" cmpd="sng">
                <a:solidFill>
                  <a:schemeClr val="tx1"/>
                </a:solidFill>
                <a:prstDash val="solid"/>
                <a:miter lim="800000"/>
                <a:headEnd type="none"/>
                <a:tailEnd type="none" w="lg" len="lg"/>
              </a:ln>
              <a:effectLst/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lang="de-DE" dirty="0"/>
              </a:p>
            </p:txBody>
          </p:sp>
        </p:grpSp>
        <p:sp>
          <p:nvSpPr>
            <p:cNvPr id="7" name="Textfeld 6">
              <a:extLst>
                <a:ext uri="{FF2B5EF4-FFF2-40B4-BE49-F238E27FC236}">
                  <a16:creationId xmlns:a16="http://schemas.microsoft.com/office/drawing/2014/main" id="{B7019C7D-2C4F-4750-A63C-AD6C5E4AA748}"/>
                </a:ext>
              </a:extLst>
            </p:cNvPr>
            <p:cNvSpPr txBox="1"/>
            <p:nvPr/>
          </p:nvSpPr>
          <p:spPr>
            <a:xfrm>
              <a:off x="415898" y="49599"/>
              <a:ext cx="1191922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b="1" dirty="0"/>
                <a:t>Proteomics</a:t>
              </a:r>
            </a:p>
          </p:txBody>
        </p:sp>
        <p:sp>
          <p:nvSpPr>
            <p:cNvPr id="8" name="Textfeld 7">
              <a:extLst>
                <a:ext uri="{FF2B5EF4-FFF2-40B4-BE49-F238E27FC236}">
                  <a16:creationId xmlns:a16="http://schemas.microsoft.com/office/drawing/2014/main" id="{7B3713D2-EA20-40D4-BC88-B6B9F36CE167}"/>
                </a:ext>
              </a:extLst>
            </p:cNvPr>
            <p:cNvSpPr txBox="1"/>
            <p:nvPr/>
          </p:nvSpPr>
          <p:spPr>
            <a:xfrm>
              <a:off x="2569812" y="50139"/>
              <a:ext cx="1104443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600" b="1" dirty="0"/>
                <a:t>Genomics</a:t>
              </a:r>
              <a:endParaRPr lang="de-DE" sz="1400" b="1" dirty="0"/>
            </a:p>
          </p:txBody>
        </p:sp>
      </p:grpSp>
      <p:sp>
        <p:nvSpPr>
          <p:cNvPr id="29" name="Rechteck 28">
            <a:extLst>
              <a:ext uri="{FF2B5EF4-FFF2-40B4-BE49-F238E27FC236}">
                <a16:creationId xmlns:a16="http://schemas.microsoft.com/office/drawing/2014/main" id="{64F3F853-0FD5-472F-9473-99301F114727}"/>
              </a:ext>
            </a:extLst>
          </p:cNvPr>
          <p:cNvSpPr/>
          <p:nvPr/>
        </p:nvSpPr>
        <p:spPr>
          <a:xfrm>
            <a:off x="0" y="5911954"/>
            <a:ext cx="4068763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</a:rPr>
              <a:t>Figure S1: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Overview of the experimental steps for the analysis of sucrose-induced changes in the proteomic profile of L. sakei TMW 1.411. This figure is partly based on Figure 1 of Schott et al. (Schott et al., 2017)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2650299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31</Words>
  <Application>Microsoft Office PowerPoint</Application>
  <PresentationFormat>Benutzerdefiniert</PresentationFormat>
  <Paragraphs>25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man Prechtl</dc:creator>
  <cp:lastModifiedBy>Roman Prechtl</cp:lastModifiedBy>
  <cp:revision>16</cp:revision>
  <dcterms:created xsi:type="dcterms:W3CDTF">2018-08-11T15:49:51Z</dcterms:created>
  <dcterms:modified xsi:type="dcterms:W3CDTF">2018-10-22T13:48:36Z</dcterms:modified>
</cp:coreProperties>
</file>